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enthil-Kumar Muthappa" initials="SM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8413" autoAdjust="0"/>
  </p:normalViewPr>
  <p:slideViewPr>
    <p:cSldViewPr>
      <p:cViewPr varScale="1">
        <p:scale>
          <a:sx n="56" d="100"/>
          <a:sy n="56" d="100"/>
        </p:scale>
        <p:origin x="2202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74D527-8677-458D-A945-C626A075FFA4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EFCBC5-5A49-491A-B23C-DB83C0BBEA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506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Admin\Desktop\ramu sir_blast2go\function\function_cut 10.png"/>
          <p:cNvPicPr>
            <a:picLocks noChangeAspect="1" noChangeArrowheads="1"/>
          </p:cNvPicPr>
          <p:nvPr/>
        </p:nvPicPr>
        <p:blipFill rotWithShape="1">
          <a:blip r:embed="rId2" cstate="print"/>
          <a:srcRect l="7610" t="5172" r="11726"/>
          <a:stretch/>
        </p:blipFill>
        <p:spPr bwMode="auto">
          <a:xfrm>
            <a:off x="152400" y="1447800"/>
            <a:ext cx="6618186" cy="3611593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73342" y="5300697"/>
            <a:ext cx="62036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Classification of up-regulated genes identified from meta-analysis based on molecular function using Blast2GO tool. Total of 52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p-regulated gen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shared under various stress. These genes were classified based on the molecular function. Numbers in parenthesis indicate the total number of genes under the respective category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8</TotalTime>
  <Words>5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mu's</dc:creator>
  <cp:lastModifiedBy>Senthil-Kumar Muthappa</cp:lastModifiedBy>
  <cp:revision>136</cp:revision>
  <dcterms:created xsi:type="dcterms:W3CDTF">2006-08-16T00:00:00Z</dcterms:created>
  <dcterms:modified xsi:type="dcterms:W3CDTF">2015-07-17T04:37:25Z</dcterms:modified>
</cp:coreProperties>
</file>